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24" r:id="rId2"/>
    <p:sldId id="326" r:id="rId3"/>
  </p:sldIdLst>
  <p:sldSz cx="9144000" cy="6858000" type="screen4x3"/>
  <p:notesSz cx="6864350" cy="999648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364" autoAdjust="0"/>
    <p:restoredTop sz="82646" autoAdjust="0"/>
  </p:normalViewPr>
  <p:slideViewPr>
    <p:cSldViewPr>
      <p:cViewPr varScale="1">
        <p:scale>
          <a:sx n="211" d="100"/>
          <a:sy n="211" d="100"/>
        </p:scale>
        <p:origin x="-78" y="-85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4552" cy="499824"/>
          </a:xfrm>
          <a:prstGeom prst="rect">
            <a:avLst/>
          </a:prstGeom>
        </p:spPr>
        <p:txBody>
          <a:bodyPr vert="horz" lIns="96341" tIns="48171" rIns="96341" bIns="48171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8210" y="0"/>
            <a:ext cx="2974552" cy="499824"/>
          </a:xfrm>
          <a:prstGeom prst="rect">
            <a:avLst/>
          </a:prstGeom>
        </p:spPr>
        <p:txBody>
          <a:bodyPr vert="horz" lIns="96341" tIns="48171" rIns="96341" bIns="48171" rtlCol="0"/>
          <a:lstStyle>
            <a:lvl1pPr algn="r">
              <a:defRPr sz="1300"/>
            </a:lvl1pPr>
          </a:lstStyle>
          <a:p>
            <a:fld id="{D97C99E4-DE50-4FE5-B92F-0ACC282F9EEF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33450" y="749300"/>
            <a:ext cx="4997450" cy="37496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341" tIns="48171" rIns="96341" bIns="48171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6435" y="4748332"/>
            <a:ext cx="5491480" cy="4498420"/>
          </a:xfrm>
          <a:prstGeom prst="rect">
            <a:avLst/>
          </a:prstGeom>
        </p:spPr>
        <p:txBody>
          <a:bodyPr vert="horz" lIns="96341" tIns="48171" rIns="96341" bIns="48171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94929"/>
            <a:ext cx="2974552" cy="499824"/>
          </a:xfrm>
          <a:prstGeom prst="rect">
            <a:avLst/>
          </a:prstGeom>
        </p:spPr>
        <p:txBody>
          <a:bodyPr vert="horz" lIns="96341" tIns="48171" rIns="96341" bIns="48171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8210" y="9494929"/>
            <a:ext cx="2974552" cy="499824"/>
          </a:xfrm>
          <a:prstGeom prst="rect">
            <a:avLst/>
          </a:prstGeom>
        </p:spPr>
        <p:txBody>
          <a:bodyPr vert="horz" lIns="96341" tIns="48171" rIns="96341" bIns="48171" rtlCol="0" anchor="b"/>
          <a:lstStyle>
            <a:lvl1pPr algn="r">
              <a:defRPr sz="1300"/>
            </a:lvl1pPr>
          </a:lstStyle>
          <a:p>
            <a:fld id="{9E2178D6-D037-4EC1-A871-AF538CD40B9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87728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MRS overexpression was most strongly</a:t>
            </a:r>
            <a:r>
              <a:rPr lang="en-US" altLang="ko-KR" baseline="0" dirty="0" smtClean="0"/>
              <a:t> correlated to pS6 followed by HSP70, CDK4 and LRS. 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7E302D-9A74-4E0E-8B2A-CD87CF9DB650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15020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3010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1951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0187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6506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34975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07321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9176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0653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08909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4215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702861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0497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9112" y="533236"/>
            <a:ext cx="5565775" cy="556006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3986"/>
            <a:ext cx="1223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upporting data 3 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3529" y="6187370"/>
            <a:ext cx="864096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upporting data 3. 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Expression of MRS and other related proteins in human NSCLC (A) and their correlation table (B). (A) </a:t>
            </a:r>
            <a:r>
              <a:rPr lang="en-US" altLang="ko-KR" sz="1000" dirty="0" smtClean="0"/>
              <a:t>The </a:t>
            </a:r>
            <a:r>
              <a:rPr lang="en-US" altLang="ko-KR" sz="1000" dirty="0"/>
              <a:t>expression of </a:t>
            </a:r>
            <a:r>
              <a:rPr lang="en-US" altLang="ko-KR" sz="1000" dirty="0" smtClean="0"/>
              <a:t>proteins was evaluated </a:t>
            </a:r>
            <a:r>
              <a:rPr lang="en-US" altLang="ko-KR" sz="1000" dirty="0"/>
              <a:t>by IHC in tissue samples from </a:t>
            </a:r>
            <a:r>
              <a:rPr lang="en-US" altLang="ko-KR" sz="1000" dirty="0" smtClean="0"/>
              <a:t>the same section. (B) Pearson </a:t>
            </a:r>
            <a:r>
              <a:rPr lang="en-US" altLang="ko-KR" sz="1000" dirty="0"/>
              <a:t>correlation coefficient </a:t>
            </a:r>
            <a:r>
              <a:rPr lang="en-US" altLang="ko-KR" sz="1000" dirty="0" smtClean="0"/>
              <a:t>table relative </a:t>
            </a:r>
            <a:r>
              <a:rPr lang="en-US" altLang="ko-KR" sz="1000" dirty="0"/>
              <a:t>to the expression of </a:t>
            </a:r>
            <a:r>
              <a:rPr lang="en-US" altLang="ko-KR" sz="1000" dirty="0" smtClean="0"/>
              <a:t>MRS expression</a:t>
            </a:r>
            <a:r>
              <a:rPr lang="en-US" altLang="ko-KR" sz="1000" dirty="0"/>
              <a:t>. </a:t>
            </a:r>
            <a:r>
              <a:rPr lang="en-US" altLang="ko-KR" sz="1000" dirty="0" smtClean="0"/>
              <a:t>P-value was obtained from bivariate correlation analysis.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7098716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1937735"/>
              </p:ext>
            </p:extLst>
          </p:nvPr>
        </p:nvGraphicFramePr>
        <p:xfrm>
          <a:off x="899592" y="1412782"/>
          <a:ext cx="7668663" cy="3943038"/>
        </p:xfrm>
        <a:graphic>
          <a:graphicData uri="http://schemas.openxmlformats.org/drawingml/2006/table">
            <a:tbl>
              <a:tblPr/>
              <a:tblGrid>
                <a:gridCol w="991051"/>
                <a:gridCol w="1311314"/>
                <a:gridCol w="766614"/>
                <a:gridCol w="766614"/>
                <a:gridCol w="766614"/>
                <a:gridCol w="766614"/>
                <a:gridCol w="766614"/>
                <a:gridCol w="766614"/>
                <a:gridCol w="766614"/>
              </a:tblGrid>
              <a:tr h="179229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　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　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AIMP2-DX2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RS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MRS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Bcl-xL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S6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KRAS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HSP70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AIMP2-DX2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earson Correlation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.00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5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72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239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0.006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0.044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0.172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-value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0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552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353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1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949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63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6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　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N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7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8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7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4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1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RS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earson Correlation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5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.00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211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149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5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0.058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0.089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-value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552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.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22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108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55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523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341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　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N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8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8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23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8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MRS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earson Correlation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72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211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.00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151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30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0.089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24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-value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353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22 </a:t>
                      </a:r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*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.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106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01* 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34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09 </a:t>
                      </a:r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*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　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N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7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8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6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3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Bcl-xL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earson Correlation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239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149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151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.00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5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0.12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0.064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-value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1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108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106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.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59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18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496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　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N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4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6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4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6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S6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earson Correlation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0.006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5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30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5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.00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1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11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-value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949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55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01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59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0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87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24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　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N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1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3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4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4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4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KRAS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earson Correlation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0.044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0.058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0.089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0.12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1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.00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8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-value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63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523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34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182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87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.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354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　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N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23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6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4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23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HSP70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earson Correlation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0.172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0.089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24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0.064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11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8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.000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-value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6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341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009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496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24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354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.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9229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　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N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5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8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4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7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18 </a:t>
                      </a:r>
                    </a:p>
                  </a:txBody>
                  <a:tcPr marL="7383" marR="7383" marT="73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890803" y="1052736"/>
            <a:ext cx="38972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</a:t>
            </a:r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. Table of correlation between MRS and 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ther related proteins.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7364727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65</TotalTime>
  <Words>304</Words>
  <Application>Microsoft Office PowerPoint</Application>
  <PresentationFormat>화면 슬라이드 쇼(4:3)</PresentationFormat>
  <Paragraphs>194</Paragraphs>
  <Slides>2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3" baseType="lpstr">
      <vt:lpstr>Office 테마</vt:lpstr>
      <vt:lpstr>PowerPoint 프레젠테이션</vt:lpstr>
      <vt:lpstr>PowerPoint 프레젠테이션</vt:lpstr>
    </vt:vector>
  </TitlesOfParts>
  <Company>연세의료원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조은나(강남)호흡기내과)</dc:creator>
  <cp:lastModifiedBy>장윤수(강남)호흡기내과)</cp:lastModifiedBy>
  <cp:revision>266</cp:revision>
  <cp:lastPrinted>2016-02-27T03:20:14Z</cp:lastPrinted>
  <dcterms:created xsi:type="dcterms:W3CDTF">2015-09-01T05:29:24Z</dcterms:created>
  <dcterms:modified xsi:type="dcterms:W3CDTF">2017-01-12T09:10:55Z</dcterms:modified>
</cp:coreProperties>
</file>